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2" d="100"/>
          <a:sy n="72" d="100"/>
        </p:scale>
        <p:origin x="-1902" y="-10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053DC0-1793-4711-8871-4E2958C18704}" type="datetimeFigureOut">
              <a:rPr lang="en-US" smtClean="0"/>
              <a:t>3/19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58254-DBF9-4968-AFC2-E3FB8EB02B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67789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053DC0-1793-4711-8871-4E2958C18704}" type="datetimeFigureOut">
              <a:rPr lang="en-US" smtClean="0"/>
              <a:t>3/19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58254-DBF9-4968-AFC2-E3FB8EB02B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070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053DC0-1793-4711-8871-4E2958C18704}" type="datetimeFigureOut">
              <a:rPr lang="en-US" smtClean="0"/>
              <a:t>3/19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58254-DBF9-4968-AFC2-E3FB8EB02B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83895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053DC0-1793-4711-8871-4E2958C18704}" type="datetimeFigureOut">
              <a:rPr lang="en-US" smtClean="0"/>
              <a:t>3/19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58254-DBF9-4968-AFC2-E3FB8EB02B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88119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053DC0-1793-4711-8871-4E2958C18704}" type="datetimeFigureOut">
              <a:rPr lang="en-US" smtClean="0"/>
              <a:t>3/19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58254-DBF9-4968-AFC2-E3FB8EB02B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68459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053DC0-1793-4711-8871-4E2958C18704}" type="datetimeFigureOut">
              <a:rPr lang="en-US" smtClean="0"/>
              <a:t>3/19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58254-DBF9-4968-AFC2-E3FB8EB02B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53226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053DC0-1793-4711-8871-4E2958C18704}" type="datetimeFigureOut">
              <a:rPr lang="en-US" smtClean="0"/>
              <a:t>3/19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58254-DBF9-4968-AFC2-E3FB8EB02B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81405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053DC0-1793-4711-8871-4E2958C18704}" type="datetimeFigureOut">
              <a:rPr lang="en-US" smtClean="0"/>
              <a:t>3/19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58254-DBF9-4968-AFC2-E3FB8EB02B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34086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053DC0-1793-4711-8871-4E2958C18704}" type="datetimeFigureOut">
              <a:rPr lang="en-US" smtClean="0"/>
              <a:t>3/19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58254-DBF9-4968-AFC2-E3FB8EB02B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43437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053DC0-1793-4711-8871-4E2958C18704}" type="datetimeFigureOut">
              <a:rPr lang="en-US" smtClean="0"/>
              <a:t>3/19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58254-DBF9-4968-AFC2-E3FB8EB02B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86005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053DC0-1793-4711-8871-4E2958C18704}" type="datetimeFigureOut">
              <a:rPr lang="en-US" smtClean="0"/>
              <a:t>3/19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58254-DBF9-4968-AFC2-E3FB8EB02B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863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053DC0-1793-4711-8871-4E2958C18704}" type="datetimeFigureOut">
              <a:rPr lang="en-US" smtClean="0"/>
              <a:t>3/19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C58254-DBF9-4968-AFC2-E3FB8EB02B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84182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/>
          <p:cNvGrpSpPr/>
          <p:nvPr/>
        </p:nvGrpSpPr>
        <p:grpSpPr>
          <a:xfrm>
            <a:off x="990600" y="228600"/>
            <a:ext cx="5099003" cy="7353300"/>
            <a:chOff x="1447800" y="-2362200"/>
            <a:chExt cx="7467600" cy="9906000"/>
          </a:xfrm>
        </p:grpSpPr>
        <p:pic>
          <p:nvPicPr>
            <p:cNvPr id="9" name="Picture 8" descr="D:\Toxo\Phylogenetic tree.emf"/>
            <p:cNvPicPr/>
            <p:nvPr/>
          </p:nvPicPr>
          <p:blipFill>
            <a:blip r:embed="rId2"/>
            <a:srcRect/>
            <a:stretch>
              <a:fillRect/>
            </a:stretch>
          </p:blipFill>
          <p:spPr bwMode="auto">
            <a:xfrm>
              <a:off x="1447800" y="-2362200"/>
              <a:ext cx="7467600" cy="9906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cxnSp>
          <p:nvCxnSpPr>
            <p:cNvPr id="10" name="Straight Arrow Connector 9"/>
            <p:cNvCxnSpPr/>
            <p:nvPr/>
          </p:nvCxnSpPr>
          <p:spPr>
            <a:xfrm rot="10800000">
              <a:off x="6535080" y="4326192"/>
              <a:ext cx="1080000" cy="1588"/>
            </a:xfrm>
            <a:prstGeom prst="straightConnector1">
              <a:avLst/>
            </a:prstGeom>
            <a:noFill/>
            <a:ln w="9525" cap="flat" cmpd="sng" algn="ctr">
              <a:solidFill>
                <a:srgbClr val="FF0000"/>
              </a:solidFill>
              <a:prstDash val="solid"/>
              <a:tailEnd type="arrow"/>
            </a:ln>
            <a:effectLst/>
          </p:spPr>
        </p:cxnSp>
        <p:cxnSp>
          <p:nvCxnSpPr>
            <p:cNvPr id="11" name="Straight Arrow Connector 10"/>
            <p:cNvCxnSpPr/>
            <p:nvPr/>
          </p:nvCxnSpPr>
          <p:spPr>
            <a:xfrm rot="10800000">
              <a:off x="6495756" y="684095"/>
              <a:ext cx="1080000" cy="1588"/>
            </a:xfrm>
            <a:prstGeom prst="straightConnector1">
              <a:avLst/>
            </a:prstGeom>
            <a:noFill/>
            <a:ln w="9525" cap="flat" cmpd="sng" algn="ctr">
              <a:solidFill>
                <a:srgbClr val="FF0000"/>
              </a:solidFill>
              <a:prstDash val="solid"/>
              <a:tailEnd type="arrow"/>
            </a:ln>
            <a:effectLst/>
          </p:spPr>
        </p:cxnSp>
      </p:grpSp>
      <p:sp>
        <p:nvSpPr>
          <p:cNvPr id="12" name="TextBox 11"/>
          <p:cNvSpPr txBox="1"/>
          <p:nvPr/>
        </p:nvSpPr>
        <p:spPr>
          <a:xfrm>
            <a:off x="546652" y="7581900"/>
            <a:ext cx="6019800" cy="1200329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1. A phylogenetic tree showing the relationship between the amino acid sequences of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Puf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members.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The tree includes all members from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T. </a:t>
            </a:r>
            <a:r>
              <a:rPr lang="en-US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gondii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Tg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and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P.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falciparum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(Pf), and representative members from mouse, human (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HsPum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, </a:t>
            </a:r>
            <a:r>
              <a:rPr lang="en-US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Xenopu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Drosophila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DrPumilio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, </a:t>
            </a:r>
            <a:r>
              <a:rPr lang="en-US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Caenorhabditis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elegan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(Ce),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Saccharomyces </a:t>
            </a:r>
            <a:r>
              <a:rPr lang="en-US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cerevisiae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Sc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, </a:t>
            </a:r>
            <a:r>
              <a:rPr lang="en-US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Leishmani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Trypanosom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Arabidopsis,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Neurospor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Only the PUM-HDs were used for alignment.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TgPuf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re highlighted with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rrows.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029247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86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wangcui</dc:creator>
  <cp:lastModifiedBy>liwangcui</cp:lastModifiedBy>
  <cp:revision>1</cp:revision>
  <dcterms:created xsi:type="dcterms:W3CDTF">2014-03-19T17:18:09Z</dcterms:created>
  <dcterms:modified xsi:type="dcterms:W3CDTF">2014-03-19T17:27:34Z</dcterms:modified>
</cp:coreProperties>
</file>